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 varScale="1">
        <p:scale>
          <a:sx n="104" d="100"/>
          <a:sy n="104" d="100"/>
        </p:scale>
        <p:origin x="-1104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dhaggy:Desktop:&#30740;&#31350;&#65288;&#36914;&#34892;&#20013;&#65289;:AtrR:disc%20plate%20assay:131207,%20disc%20plate%20assay,%20GMM+azoles%20(DMI),%20Af293,%20atrR,%20Co-atrR,%20srbA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dhaggy:Desktop:&#30740;&#31350;&#65288;&#36914;&#34892;&#20013;&#65289;:AtrR:disc%20plate%20assay:131207,%20disc%20plate%20assay,%20GMM+azoles%20(DMI),%20Af293,%20atrR,%20Co-atrR,%20srbA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dhaggy:Desktop:&#30740;&#31350;&#65288;&#36914;&#34892;&#20013;&#65289;:AtrR:disc%20plate%20assay:131207,%20disc%20plate%20assay,%20GMM+azoles%20(DMI),%20Af293,%20atrR,%20Co-atrR,%20srbA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dhaggy:Desktop:&#30740;&#31350;&#65288;&#36914;&#34892;&#20013;&#65289;:AtrR:disc%20plate%20assay:131207,%20disc%20plate%20assay,%20GMM+azoles%20(DMI),%20Af293,%20atrR,%20Co-atrR,%20srb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Sheet1!$J$4:$J$6</c:f>
                <c:numCache>
                  <c:formatCode>General</c:formatCode>
                  <c:ptCount val="3"/>
                  <c:pt idx="0">
                    <c:v>5.312459150169739</c:v>
                  </c:pt>
                  <c:pt idx="1">
                    <c:v>0.0</c:v>
                  </c:pt>
                  <c:pt idx="2">
                    <c:v>0.0</c:v>
                  </c:pt>
                </c:numCache>
              </c:numRef>
            </c:plus>
            <c:minus>
              <c:numRef>
                <c:f>Sheet1!$J$4:$J$6</c:f>
                <c:numCache>
                  <c:formatCode>General</c:formatCode>
                  <c:ptCount val="3"/>
                  <c:pt idx="0">
                    <c:v>5.312459150169739</c:v>
                  </c:pt>
                  <c:pt idx="1">
                    <c:v>0.0</c:v>
                  </c:pt>
                  <c:pt idx="2">
                    <c:v>0.0</c:v>
                  </c:pt>
                </c:numCache>
              </c:numRef>
            </c:minus>
          </c:errBars>
          <c:cat>
            <c:strRef>
              <c:f>Sheet1!$H$4:$H$5</c:f>
              <c:strCache>
                <c:ptCount val="2"/>
                <c:pt idx="0">
                  <c:v>Af293</c:v>
                </c:pt>
                <c:pt idx="1">
                  <c:v>atrR</c:v>
                </c:pt>
              </c:strCache>
            </c:strRef>
          </c:cat>
          <c:val>
            <c:numRef>
              <c:f>Sheet1!$I$4:$I$5</c:f>
              <c:numCache>
                <c:formatCode>0.0</c:formatCode>
                <c:ptCount val="2"/>
                <c:pt idx="0">
                  <c:v>22.3333333333333</c:v>
                </c:pt>
                <c:pt idx="1">
                  <c:v>8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736942488"/>
        <c:axId val="680802296"/>
      </c:barChart>
      <c:catAx>
        <c:axId val="736942488"/>
        <c:scaling>
          <c:orientation val="minMax"/>
        </c:scaling>
        <c:delete val="0"/>
        <c:axPos val="b"/>
        <c:majorTickMark val="out"/>
        <c:minorTickMark val="none"/>
        <c:tickLblPos val="nextTo"/>
        <c:crossAx val="680802296"/>
        <c:crosses val="autoZero"/>
        <c:auto val="1"/>
        <c:lblAlgn val="ctr"/>
        <c:lblOffset val="100"/>
        <c:noMultiLvlLbl val="0"/>
      </c:catAx>
      <c:valAx>
        <c:axId val="680802296"/>
        <c:scaling>
          <c:orientation val="minMax"/>
          <c:max val="100.0"/>
        </c:scaling>
        <c:delete val="0"/>
        <c:axPos val="l"/>
        <c:numFmt formatCode="General" sourceLinked="0"/>
        <c:majorTickMark val="out"/>
        <c:minorTickMark val="none"/>
        <c:tickLblPos val="nextTo"/>
        <c:crossAx val="736942488"/>
        <c:crosses val="autoZero"/>
        <c:crossBetween val="between"/>
        <c:majorUnit val="20.0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Sheet1!$J$10:$J$12</c:f>
                <c:numCache>
                  <c:formatCode>General</c:formatCode>
                  <c:ptCount val="3"/>
                  <c:pt idx="0">
                    <c:v>0.471404520791032</c:v>
                  </c:pt>
                  <c:pt idx="1">
                    <c:v>6.342099196813483</c:v>
                  </c:pt>
                  <c:pt idx="2">
                    <c:v>2.054804667656326</c:v>
                  </c:pt>
                </c:numCache>
              </c:numRef>
            </c:plus>
            <c:minus>
              <c:numRef>
                <c:f>Sheet1!$J$10:$J$12</c:f>
                <c:numCache>
                  <c:formatCode>General</c:formatCode>
                  <c:ptCount val="3"/>
                  <c:pt idx="0">
                    <c:v>0.471404520791032</c:v>
                  </c:pt>
                  <c:pt idx="1">
                    <c:v>6.342099196813483</c:v>
                  </c:pt>
                  <c:pt idx="2">
                    <c:v>2.054804667656326</c:v>
                  </c:pt>
                </c:numCache>
              </c:numRef>
            </c:minus>
          </c:errBars>
          <c:cat>
            <c:strRef>
              <c:f>Sheet1!$H$10:$H$12</c:f>
              <c:strCache>
                <c:ptCount val="3"/>
                <c:pt idx="0">
                  <c:v>Af293</c:v>
                </c:pt>
                <c:pt idx="1">
                  <c:v>atrR</c:v>
                </c:pt>
                <c:pt idx="2">
                  <c:v>srbA</c:v>
                </c:pt>
              </c:strCache>
            </c:strRef>
          </c:cat>
          <c:val>
            <c:numRef>
              <c:f>Sheet1!$I$10:$I$11</c:f>
              <c:numCache>
                <c:formatCode>0.0</c:formatCode>
                <c:ptCount val="2"/>
                <c:pt idx="0">
                  <c:v>36.33333333333334</c:v>
                </c:pt>
                <c:pt idx="1">
                  <c:v>66.3333333333332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480613832"/>
        <c:axId val="480665432"/>
      </c:barChart>
      <c:catAx>
        <c:axId val="480613832"/>
        <c:scaling>
          <c:orientation val="minMax"/>
        </c:scaling>
        <c:delete val="0"/>
        <c:axPos val="b"/>
        <c:majorTickMark val="out"/>
        <c:minorTickMark val="none"/>
        <c:tickLblPos val="nextTo"/>
        <c:crossAx val="480665432"/>
        <c:crosses val="autoZero"/>
        <c:auto val="1"/>
        <c:lblAlgn val="ctr"/>
        <c:lblOffset val="100"/>
        <c:noMultiLvlLbl val="0"/>
      </c:catAx>
      <c:valAx>
        <c:axId val="480665432"/>
        <c:scaling>
          <c:orientation val="minMax"/>
          <c:max val="100.0"/>
        </c:scaling>
        <c:delete val="0"/>
        <c:axPos val="l"/>
        <c:numFmt formatCode="General" sourceLinked="0"/>
        <c:majorTickMark val="out"/>
        <c:minorTickMark val="none"/>
        <c:tickLblPos val="nextTo"/>
        <c:crossAx val="480613832"/>
        <c:crosses val="autoZero"/>
        <c:crossBetween val="between"/>
        <c:majorUnit val="20.0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Sheet1!$J$16:$J$18</c:f>
                <c:numCache>
                  <c:formatCode>General</c:formatCode>
                  <c:ptCount val="3"/>
                  <c:pt idx="0">
                    <c:v>1.247219128924647</c:v>
                  </c:pt>
                  <c:pt idx="1">
                    <c:v>2.943920288775948</c:v>
                  </c:pt>
                  <c:pt idx="2">
                    <c:v>1.632993161855452</c:v>
                  </c:pt>
                </c:numCache>
              </c:numRef>
            </c:plus>
            <c:minus>
              <c:numRef>
                <c:f>Sheet1!$J$16:$J$18</c:f>
                <c:numCache>
                  <c:formatCode>General</c:formatCode>
                  <c:ptCount val="3"/>
                  <c:pt idx="0">
                    <c:v>1.247219128924647</c:v>
                  </c:pt>
                  <c:pt idx="1">
                    <c:v>2.943920288775948</c:v>
                  </c:pt>
                  <c:pt idx="2">
                    <c:v>1.632993161855452</c:v>
                  </c:pt>
                </c:numCache>
              </c:numRef>
            </c:minus>
          </c:errBars>
          <c:cat>
            <c:strRef>
              <c:f>Sheet1!$H$16:$H$18</c:f>
              <c:strCache>
                <c:ptCount val="3"/>
                <c:pt idx="0">
                  <c:v>Af293</c:v>
                </c:pt>
                <c:pt idx="1">
                  <c:v>atrR</c:v>
                </c:pt>
                <c:pt idx="2">
                  <c:v>srbA</c:v>
                </c:pt>
              </c:strCache>
            </c:strRef>
          </c:cat>
          <c:val>
            <c:numRef>
              <c:f>Sheet1!$I$16:$I$17</c:f>
              <c:numCache>
                <c:formatCode>0.0</c:formatCode>
                <c:ptCount val="2"/>
                <c:pt idx="0">
                  <c:v>20.3333333333333</c:v>
                </c:pt>
                <c:pt idx="1">
                  <c:v>71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682547704"/>
        <c:axId val="682279112"/>
      </c:barChart>
      <c:catAx>
        <c:axId val="682547704"/>
        <c:scaling>
          <c:orientation val="minMax"/>
        </c:scaling>
        <c:delete val="0"/>
        <c:axPos val="b"/>
        <c:majorTickMark val="out"/>
        <c:minorTickMark val="none"/>
        <c:tickLblPos val="nextTo"/>
        <c:crossAx val="682279112"/>
        <c:crosses val="autoZero"/>
        <c:auto val="1"/>
        <c:lblAlgn val="ctr"/>
        <c:lblOffset val="100"/>
        <c:noMultiLvlLbl val="0"/>
      </c:catAx>
      <c:valAx>
        <c:axId val="682279112"/>
        <c:scaling>
          <c:orientation val="minMax"/>
          <c:max val="100.0"/>
        </c:scaling>
        <c:delete val="0"/>
        <c:axPos val="l"/>
        <c:numFmt formatCode="General" sourceLinked="0"/>
        <c:majorTickMark val="out"/>
        <c:minorTickMark val="none"/>
        <c:tickLblPos val="nextTo"/>
        <c:crossAx val="682547704"/>
        <c:crosses val="autoZero"/>
        <c:crossBetween val="between"/>
        <c:majorUnit val="20.0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Sheet1!$J$22:$J$24</c:f>
                <c:numCache>
                  <c:formatCode>General</c:formatCode>
                  <c:ptCount val="3"/>
                  <c:pt idx="0">
                    <c:v>0.816496580927726</c:v>
                  </c:pt>
                  <c:pt idx="1">
                    <c:v>0.0</c:v>
                  </c:pt>
                  <c:pt idx="2">
                    <c:v>0.0</c:v>
                  </c:pt>
                </c:numCache>
              </c:numRef>
            </c:plus>
            <c:minus>
              <c:numRef>
                <c:f>Sheet1!$J$22:$J$24</c:f>
                <c:numCache>
                  <c:formatCode>General</c:formatCode>
                  <c:ptCount val="3"/>
                  <c:pt idx="0">
                    <c:v>0.816496580927726</c:v>
                  </c:pt>
                  <c:pt idx="1">
                    <c:v>0.0</c:v>
                  </c:pt>
                  <c:pt idx="2">
                    <c:v>0.0</c:v>
                  </c:pt>
                </c:numCache>
              </c:numRef>
            </c:minus>
          </c:errBars>
          <c:cat>
            <c:strRef>
              <c:f>Sheet1!$H$22:$H$24</c:f>
              <c:strCache>
                <c:ptCount val="3"/>
                <c:pt idx="0">
                  <c:v>Af293</c:v>
                </c:pt>
                <c:pt idx="1">
                  <c:v>atrR</c:v>
                </c:pt>
                <c:pt idx="2">
                  <c:v>srbA</c:v>
                </c:pt>
              </c:strCache>
            </c:strRef>
          </c:cat>
          <c:val>
            <c:numRef>
              <c:f>Sheet1!$I$22:$I$23</c:f>
              <c:numCache>
                <c:formatCode>0.0</c:formatCode>
                <c:ptCount val="2"/>
                <c:pt idx="0">
                  <c:v>20.0</c:v>
                </c:pt>
                <c:pt idx="1">
                  <c:v>8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878650072"/>
        <c:axId val="736996152"/>
      </c:barChart>
      <c:catAx>
        <c:axId val="878650072"/>
        <c:scaling>
          <c:orientation val="minMax"/>
        </c:scaling>
        <c:delete val="0"/>
        <c:axPos val="b"/>
        <c:majorTickMark val="out"/>
        <c:minorTickMark val="none"/>
        <c:tickLblPos val="nextTo"/>
        <c:crossAx val="736996152"/>
        <c:crosses val="autoZero"/>
        <c:auto val="1"/>
        <c:lblAlgn val="ctr"/>
        <c:lblOffset val="100"/>
        <c:noMultiLvlLbl val="0"/>
      </c:catAx>
      <c:valAx>
        <c:axId val="736996152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crossAx val="878650072"/>
        <c:crosses val="autoZero"/>
        <c:crossBetween val="between"/>
        <c:majorUnit val="20.0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062B1-2448-5F42-BA7E-2D4A125942DB}" type="datetimeFigureOut">
              <a:rPr kumimoji="1" lang="ja-JP" altLang="en-US" smtClean="0"/>
              <a:t>16/12/0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22D8F-6B39-3B4F-B82A-03DF769740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18259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062B1-2448-5F42-BA7E-2D4A125942DB}" type="datetimeFigureOut">
              <a:rPr kumimoji="1" lang="ja-JP" altLang="en-US" smtClean="0"/>
              <a:t>16/12/0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22D8F-6B39-3B4F-B82A-03DF769740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35527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062B1-2448-5F42-BA7E-2D4A125942DB}" type="datetimeFigureOut">
              <a:rPr kumimoji="1" lang="ja-JP" altLang="en-US" smtClean="0"/>
              <a:t>16/12/0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22D8F-6B39-3B4F-B82A-03DF769740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44230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062B1-2448-5F42-BA7E-2D4A125942DB}" type="datetimeFigureOut">
              <a:rPr kumimoji="1" lang="ja-JP" altLang="en-US" smtClean="0"/>
              <a:t>16/12/0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22D8F-6B39-3B4F-B82A-03DF769740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06252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062B1-2448-5F42-BA7E-2D4A125942DB}" type="datetimeFigureOut">
              <a:rPr kumimoji="1" lang="ja-JP" altLang="en-US" smtClean="0"/>
              <a:t>16/12/0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22D8F-6B39-3B4F-B82A-03DF769740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44477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062B1-2448-5F42-BA7E-2D4A125942DB}" type="datetimeFigureOut">
              <a:rPr kumimoji="1" lang="ja-JP" altLang="en-US" smtClean="0"/>
              <a:t>16/12/0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22D8F-6B39-3B4F-B82A-03DF769740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30265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062B1-2448-5F42-BA7E-2D4A125942DB}" type="datetimeFigureOut">
              <a:rPr kumimoji="1" lang="ja-JP" altLang="en-US" smtClean="0"/>
              <a:t>16/12/0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22D8F-6B39-3B4F-B82A-03DF769740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27057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062B1-2448-5F42-BA7E-2D4A125942DB}" type="datetimeFigureOut">
              <a:rPr kumimoji="1" lang="ja-JP" altLang="en-US" smtClean="0"/>
              <a:t>16/12/0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22D8F-6B39-3B4F-B82A-03DF769740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94621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062B1-2448-5F42-BA7E-2D4A125942DB}" type="datetimeFigureOut">
              <a:rPr kumimoji="1" lang="ja-JP" altLang="en-US" smtClean="0"/>
              <a:t>16/12/0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22D8F-6B39-3B4F-B82A-03DF769740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63501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062B1-2448-5F42-BA7E-2D4A125942DB}" type="datetimeFigureOut">
              <a:rPr kumimoji="1" lang="ja-JP" altLang="en-US" smtClean="0"/>
              <a:t>16/12/0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22D8F-6B39-3B4F-B82A-03DF769740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46781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062B1-2448-5F42-BA7E-2D4A125942DB}" type="datetimeFigureOut">
              <a:rPr kumimoji="1" lang="ja-JP" altLang="en-US" smtClean="0"/>
              <a:t>16/12/0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22D8F-6B39-3B4F-B82A-03DF769740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13186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D062B1-2448-5F42-BA7E-2D4A125942DB}" type="datetimeFigureOut">
              <a:rPr kumimoji="1" lang="ja-JP" altLang="en-US" smtClean="0"/>
              <a:t>16/12/0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222D8F-6B39-3B4F-B82A-03DF769740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59312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グラフ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06462633"/>
              </p:ext>
            </p:extLst>
          </p:nvPr>
        </p:nvGraphicFramePr>
        <p:xfrm>
          <a:off x="956899" y="1983608"/>
          <a:ext cx="1791823" cy="228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グラフ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00929321"/>
              </p:ext>
            </p:extLst>
          </p:nvPr>
        </p:nvGraphicFramePr>
        <p:xfrm>
          <a:off x="2748722" y="1983608"/>
          <a:ext cx="1791823" cy="228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グラフ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54559612"/>
              </p:ext>
            </p:extLst>
          </p:nvPr>
        </p:nvGraphicFramePr>
        <p:xfrm>
          <a:off x="4540545" y="1983608"/>
          <a:ext cx="1791823" cy="228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" name="グラフ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18169781"/>
              </p:ext>
            </p:extLst>
          </p:nvPr>
        </p:nvGraphicFramePr>
        <p:xfrm>
          <a:off x="6332368" y="1983608"/>
          <a:ext cx="1791823" cy="228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9" name="テキスト ボックス 8"/>
          <p:cNvSpPr txBox="1"/>
          <p:nvPr/>
        </p:nvSpPr>
        <p:spPr>
          <a:xfrm>
            <a:off x="1360636" y="1829719"/>
            <a:ext cx="13160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err="1" smtClean="0"/>
              <a:t>Bromuconazole</a:t>
            </a:r>
            <a:endParaRPr kumimoji="1" lang="ja-JP" altLang="en-US" sz="1400" dirty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3173246" y="1829719"/>
            <a:ext cx="11757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err="1" smtClean="0"/>
              <a:t>Tebuconazole</a:t>
            </a:r>
            <a:endParaRPr kumimoji="1" lang="ja-JP" altLang="en-US" sz="1400" dirty="0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4928477" y="1829719"/>
            <a:ext cx="13131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err="1" smtClean="0"/>
              <a:t>Difenoconazole</a:t>
            </a:r>
            <a:endParaRPr kumimoji="1" lang="ja-JP" altLang="en-US" sz="1400" dirty="0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6772960" y="1829719"/>
            <a:ext cx="1210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err="1" smtClean="0"/>
              <a:t>Propiconazole</a:t>
            </a:r>
            <a:endParaRPr kumimoji="1" lang="ja-JP" altLang="en-US" sz="1400" dirty="0"/>
          </a:p>
        </p:txBody>
      </p:sp>
      <p:sp>
        <p:nvSpPr>
          <p:cNvPr id="13" name="テキスト ボックス 12"/>
          <p:cNvSpPr txBox="1"/>
          <p:nvPr/>
        </p:nvSpPr>
        <p:spPr>
          <a:xfrm rot="16200000">
            <a:off x="-332284" y="2834515"/>
            <a:ext cx="22408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Diameter of </a:t>
            </a:r>
            <a:r>
              <a:rPr lang="en-US" altLang="ja-JP" sz="1200" dirty="0" smtClean="0"/>
              <a:t>inhibition halo (mm)</a:t>
            </a:r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4265567690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</Words>
  <Application>Microsoft Macintosh PowerPoint</Application>
  <PresentationFormat>画面に合わせる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千葉大学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萩原 大祐</dc:creator>
  <cp:lastModifiedBy>萩原 大祐</cp:lastModifiedBy>
  <cp:revision>1</cp:revision>
  <dcterms:created xsi:type="dcterms:W3CDTF">2016-12-06T05:47:48Z</dcterms:created>
  <dcterms:modified xsi:type="dcterms:W3CDTF">2016-12-06T05:48:10Z</dcterms:modified>
</cp:coreProperties>
</file>